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45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1382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07513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30968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1083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7349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1385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9034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5686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5617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2134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3711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9CD39-C44F-495E-9D3A-C2BF5BBD2FDE}" type="datetimeFigureOut">
              <a:rPr lang="en-CA" smtClean="0"/>
              <a:t>2021-04-2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DA65B-3D2E-42B7-B8C7-46CB2314FD0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6368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76" t="6666" r="7558" b="9877"/>
          <a:stretch/>
        </p:blipFill>
        <p:spPr>
          <a:xfrm>
            <a:off x="2573867" y="135467"/>
            <a:ext cx="6560608" cy="58354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05025" y="6057900"/>
            <a:ext cx="83343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dirty="0"/>
              <a:t>Supplementary Figure 1. Average value of metabolites with standard deviation determined in CSF samples determined from 1D NOESY measurements. Shown are values prior to normalization.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9486899" y="276225"/>
            <a:ext cx="2156731" cy="1723164"/>
            <a:chOff x="9925049" y="866775"/>
            <a:chExt cx="2156731" cy="1723164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3"/>
            <a:srcRect l="14083" t="18531" r="79909" b="79566"/>
            <a:stretch/>
          </p:blipFill>
          <p:spPr>
            <a:xfrm>
              <a:off x="9925049" y="933450"/>
              <a:ext cx="590551" cy="1905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/>
            <a:srcRect l="14083" t="21862" r="79909" b="76045"/>
            <a:stretch/>
          </p:blipFill>
          <p:spPr>
            <a:xfrm>
              <a:off x="9925049" y="1142999"/>
              <a:ext cx="590551" cy="209551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/>
            <a:srcRect l="14083" t="25381" r="79909" b="72335"/>
            <a:stretch/>
          </p:blipFill>
          <p:spPr>
            <a:xfrm>
              <a:off x="9934574" y="1352551"/>
              <a:ext cx="590551" cy="2286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3"/>
            <a:srcRect l="14083" t="29092" r="79909" b="69005"/>
            <a:stretch/>
          </p:blipFill>
          <p:spPr>
            <a:xfrm>
              <a:off x="9934574" y="1581150"/>
              <a:ext cx="590551" cy="1905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3"/>
            <a:srcRect l="14083" t="32517" r="79909" b="65485"/>
            <a:stretch/>
          </p:blipFill>
          <p:spPr>
            <a:xfrm>
              <a:off x="9934574" y="1790700"/>
              <a:ext cx="590551" cy="200025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3"/>
            <a:srcRect l="14083" t="36132" r="79909" b="61965"/>
            <a:stretch/>
          </p:blipFill>
          <p:spPr>
            <a:xfrm>
              <a:off x="9944099" y="2000250"/>
              <a:ext cx="590551" cy="19050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3"/>
            <a:srcRect l="14083" t="39652" r="79909" b="58350"/>
            <a:stretch/>
          </p:blipFill>
          <p:spPr>
            <a:xfrm>
              <a:off x="9944099" y="2181225"/>
              <a:ext cx="590551" cy="200026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3"/>
            <a:srcRect l="14083" t="43268" r="79909" b="54829"/>
            <a:stretch/>
          </p:blipFill>
          <p:spPr>
            <a:xfrm>
              <a:off x="9944099" y="2371725"/>
              <a:ext cx="590551" cy="190498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10458450" y="866775"/>
              <a:ext cx="1623330" cy="17231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600"/>
                </a:lnSpc>
              </a:pPr>
              <a:r>
                <a:rPr lang="en-CA" sz="1200" dirty="0"/>
                <a:t>Male, control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Male, APP2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Male, control, 7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Male, APP2, 7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control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APP, 2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control, 9mnts</a:t>
              </a:r>
            </a:p>
            <a:p>
              <a:pPr>
                <a:lnSpc>
                  <a:spcPts val="1600"/>
                </a:lnSpc>
              </a:pPr>
              <a:r>
                <a:rPr lang="en-CA" sz="1200" dirty="0"/>
                <a:t>Female, APP, 9mnt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58973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4</TotalTime>
  <Words>68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RC-CN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perlovic-Culf, Miroslava</dc:creator>
  <cp:lastModifiedBy>HYD OFF33</cp:lastModifiedBy>
  <cp:revision>5</cp:revision>
  <dcterms:created xsi:type="dcterms:W3CDTF">2021-03-17T15:38:07Z</dcterms:created>
  <dcterms:modified xsi:type="dcterms:W3CDTF">2021-04-23T02:41:21Z</dcterms:modified>
</cp:coreProperties>
</file>